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66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3956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4655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1766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0884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784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0732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8109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6613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538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3230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7821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FBAFA-2F42-4B64-8586-EA77C51ABA23}" type="datetimeFigureOut">
              <a:rPr lang="zh-CN" altLang="en-US" smtClean="0"/>
              <a:t>2020/2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4C7A8-5AF3-4483-866D-4B041CE4140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3634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clustal.org/clustal2/" TargetMode="Externa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doua.prabi.fr/software/njplot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9903" y="833865"/>
            <a:ext cx="7430401" cy="387353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378424" y="5227093"/>
            <a:ext cx="910305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Fig. S2</a:t>
            </a:r>
            <a:r>
              <a:rPr lang="en-GB" dirty="0" smtClean="0"/>
              <a:t>. Phylogenetic tree analysis of the Pita2 haplotypes in different rice varieties. The protein sequences of the Pita2 haplotypes in 9 rice varieties as listed in Table 4 are used for building the phylogenetic tree using ClustalX(1.81) </a:t>
            </a:r>
            <a:r>
              <a:rPr lang="en-GB" dirty="0"/>
              <a:t>(</a:t>
            </a:r>
            <a:r>
              <a:rPr lang="en-GB" dirty="0">
                <a:hlinkClick r:id="rId3"/>
              </a:rPr>
              <a:t>http://www.clustal.org/clustal2</a:t>
            </a:r>
            <a:r>
              <a:rPr lang="en-GB" dirty="0" smtClean="0">
                <a:hlinkClick r:id="rId3"/>
              </a:rPr>
              <a:t>/</a:t>
            </a:r>
            <a:r>
              <a:rPr lang="en-GB" dirty="0" smtClean="0"/>
              <a:t>), which </a:t>
            </a:r>
            <a:r>
              <a:rPr lang="en-GB" dirty="0"/>
              <a:t>is viewed by </a:t>
            </a:r>
            <a:r>
              <a:rPr lang="en-GB" dirty="0" err="1" smtClean="0"/>
              <a:t>Njplot</a:t>
            </a:r>
            <a:r>
              <a:rPr lang="en-GB" dirty="0" smtClean="0"/>
              <a:t> (</a:t>
            </a:r>
            <a:r>
              <a:rPr lang="en-GB" dirty="0" smtClean="0">
                <a:hlinkClick r:id="rId4"/>
              </a:rPr>
              <a:t>http</a:t>
            </a:r>
            <a:r>
              <a:rPr lang="en-GB" dirty="0">
                <a:hlinkClick r:id="rId4"/>
              </a:rPr>
              <a:t>://</a:t>
            </a:r>
            <a:r>
              <a:rPr lang="en-GB" dirty="0" smtClean="0">
                <a:hlinkClick r:id="rId4"/>
              </a:rPr>
              <a:t>doua.prabi.fr/software/njplot</a:t>
            </a:r>
            <a:r>
              <a:rPr lang="en-GB" dirty="0" smtClean="0"/>
              <a:t>). The sequence is represented by the name of variety from which it is identified. The branch length is indicated in scale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5610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8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等线</vt:lpstr>
      <vt:lpstr>等线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 Zhou</dc:creator>
  <cp:lastModifiedBy>Zhou, Bo (FAORAP)</cp:lastModifiedBy>
  <cp:revision>4</cp:revision>
  <dcterms:created xsi:type="dcterms:W3CDTF">2020-01-27T15:13:16Z</dcterms:created>
  <dcterms:modified xsi:type="dcterms:W3CDTF">2020-02-01T14:17:09Z</dcterms:modified>
</cp:coreProperties>
</file>